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64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141B47-9439-417A-8FC9-14096EC1D779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D1E8-D903-4940-B344-AA0A82FE18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544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141B47-9439-417A-8FC9-14096EC1D779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D1E8-D903-4940-B344-AA0A82FE18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5766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141B47-9439-417A-8FC9-14096EC1D779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D1E8-D903-4940-B344-AA0A82FE18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667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141B47-9439-417A-8FC9-14096EC1D779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D1E8-D903-4940-B344-AA0A82FE18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213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141B47-9439-417A-8FC9-14096EC1D779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D1E8-D903-4940-B344-AA0A82FE18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6646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141B47-9439-417A-8FC9-14096EC1D779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D1E8-D903-4940-B344-AA0A82FE18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751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141B47-9439-417A-8FC9-14096EC1D779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D1E8-D903-4940-B344-AA0A82FE18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1273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141B47-9439-417A-8FC9-14096EC1D779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D1E8-D903-4940-B344-AA0A82FE18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725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141B47-9439-417A-8FC9-14096EC1D779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D1E8-D903-4940-B344-AA0A82FE18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62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141B47-9439-417A-8FC9-14096EC1D779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D1E8-D903-4940-B344-AA0A82FE18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617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141B47-9439-417A-8FC9-14096EC1D779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DD1E8-D903-4940-B344-AA0A82FE18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894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141B47-9439-417A-8FC9-14096EC1D779}" type="datetimeFigureOut">
              <a:rPr lang="en-US" smtClean="0"/>
              <a:t>4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CDD1E8-D903-4940-B344-AA0A82FE18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875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8462" t="34087" r="80479" b="36282"/>
          <a:stretch/>
        </p:blipFill>
        <p:spPr>
          <a:xfrm>
            <a:off x="131010" y="3167890"/>
            <a:ext cx="1860223" cy="2803273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08544" y="427776"/>
            <a:ext cx="7605712" cy="643022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8" y="28569"/>
            <a:ext cx="3563323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The NIH Roadmap </a:t>
            </a:r>
            <a:r>
              <a:rPr lang="en-US" dirty="0" err="1"/>
              <a:t>Epigenomics</a:t>
            </a:r>
            <a:r>
              <a:rPr lang="en-US" dirty="0"/>
              <a:t> Mapping </a:t>
            </a:r>
            <a:r>
              <a:rPr lang="en-US" dirty="0" smtClean="0"/>
              <a:t>Consortium </a:t>
            </a:r>
            <a:r>
              <a:rPr lang="en-US" dirty="0" smtClean="0"/>
              <a:t>Data. Chromatin </a:t>
            </a:r>
            <a:r>
              <a:rPr lang="en-US" dirty="0"/>
              <a:t>state </a:t>
            </a:r>
            <a:r>
              <a:rPr lang="en-US" dirty="0" smtClean="0"/>
              <a:t>learning using </a:t>
            </a:r>
            <a:r>
              <a:rPr lang="en-US" dirty="0" err="1"/>
              <a:t>ChromHMM</a:t>
            </a:r>
            <a:r>
              <a:rPr lang="en-US" dirty="0"/>
              <a:t> v1.10 (Ernst et al., 2012), which is based on a multivariate Hidden Markov </a:t>
            </a:r>
            <a:r>
              <a:rPr lang="en-US" dirty="0" smtClean="0"/>
              <a:t>Model. Core 15-state </a:t>
            </a:r>
            <a:r>
              <a:rPr lang="en-US" dirty="0"/>
              <a:t>model (5 marks, 127 epigenomes</a:t>
            </a:r>
            <a:r>
              <a:rPr lang="en-US" dirty="0" smtClean="0"/>
              <a:t>) based </a:t>
            </a:r>
            <a:r>
              <a:rPr lang="en-US" dirty="0"/>
              <a:t>on </a:t>
            </a:r>
            <a:r>
              <a:rPr lang="en-US" i="1" u="sng" dirty="0" smtClean="0"/>
              <a:t>primary</a:t>
            </a:r>
            <a:r>
              <a:rPr lang="en-US" dirty="0" smtClean="0"/>
              <a:t> data around </a:t>
            </a:r>
            <a:r>
              <a:rPr lang="en-US" i="1" dirty="0" smtClean="0"/>
              <a:t>PIWIL2</a:t>
            </a:r>
            <a:r>
              <a:rPr lang="en-US" dirty="0" smtClean="0"/>
              <a:t> </a:t>
            </a:r>
            <a:r>
              <a:rPr lang="en-US" dirty="0" smtClean="0"/>
              <a:t>gene.</a:t>
            </a:r>
            <a:endParaRPr lang="en-US" dirty="0" smtClean="0"/>
          </a:p>
          <a:p>
            <a:endParaRPr lang="en-US" dirty="0"/>
          </a:p>
          <a:p>
            <a:r>
              <a:rPr lang="en-US" u="sng" dirty="0" smtClean="0"/>
              <a:t>Legend for 15 chromatin states:</a:t>
            </a:r>
            <a:endParaRPr lang="en-US" u="sng" dirty="0"/>
          </a:p>
        </p:txBody>
      </p:sp>
      <p:sp>
        <p:nvSpPr>
          <p:cNvPr id="6" name="Rectangle 5"/>
          <p:cNvSpPr/>
          <p:nvPr/>
        </p:nvSpPr>
        <p:spPr>
          <a:xfrm>
            <a:off x="6490581" y="400110"/>
            <a:ext cx="149394" cy="641032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6309656" y="-65699"/>
            <a:ext cx="72792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Alternative promoter in exon 7</a:t>
            </a:r>
            <a:endParaRPr lang="en-US" sz="900" dirty="0"/>
          </a:p>
        </p:txBody>
      </p:sp>
      <p:sp>
        <p:nvSpPr>
          <p:cNvPr id="8" name="Rectangle 5"/>
          <p:cNvSpPr/>
          <p:nvPr/>
        </p:nvSpPr>
        <p:spPr>
          <a:xfrm>
            <a:off x="6122281" y="400110"/>
            <a:ext cx="149394" cy="641032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5"/>
          <p:cNvSpPr/>
          <p:nvPr/>
        </p:nvSpPr>
        <p:spPr>
          <a:xfrm>
            <a:off x="5559520" y="400110"/>
            <a:ext cx="205007" cy="641032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5746895" y="-65699"/>
            <a:ext cx="72792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Alternative promoter in exon 5</a:t>
            </a:r>
            <a:endParaRPr lang="en-US" sz="900" dirty="0"/>
          </a:p>
        </p:txBody>
      </p:sp>
      <p:sp>
        <p:nvSpPr>
          <p:cNvPr id="13" name="TextBox 12"/>
          <p:cNvSpPr txBox="1"/>
          <p:nvPr/>
        </p:nvSpPr>
        <p:spPr>
          <a:xfrm>
            <a:off x="5151894" y="58444"/>
            <a:ext cx="727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Canonical promoter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534676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67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ldar gainetdinov</dc:creator>
  <cp:lastModifiedBy>ildar gainetdinov</cp:lastModifiedBy>
  <cp:revision>14</cp:revision>
  <dcterms:created xsi:type="dcterms:W3CDTF">2015-11-06T15:28:49Z</dcterms:created>
  <dcterms:modified xsi:type="dcterms:W3CDTF">2016-04-14T10:04:27Z</dcterms:modified>
</cp:coreProperties>
</file>